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59039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04580-68AC-4CFB-8546-0BF48C6C85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89154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412440"/>
            <a:ext cx="89154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B35BF-304E-4612-974A-F4DEF65963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41244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41244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48D70-21F1-40AD-9E94-34CD38C431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37772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37772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41244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41244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412440"/>
            <a:ext cx="287064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A0F2D-1CCB-413C-8878-AC291E5C42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377720"/>
            <a:ext cx="8915400" cy="389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5DC81-8470-47EF-9A6B-8EE16EC052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89154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D5CC1-C50D-422D-BF94-945C7E8C75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43506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377720"/>
            <a:ext cx="43506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7351F-36D0-4CB4-838D-130958B689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B3A42-CC1B-434D-B689-1BD5FC05A4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36520"/>
            <a:ext cx="8915400" cy="4563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10EDF-DF90-486F-95B5-9C29A58651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377720"/>
            <a:ext cx="43506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41244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B8E84-1AB4-4252-BD8C-94936D89D3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43506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41244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9E282-B14C-431D-B847-47CF7BC95F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377720"/>
            <a:ext cx="43506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412440"/>
            <a:ext cx="8915400" cy="185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57AB6-824C-42F6-88B3-99FC8775FA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36520"/>
            <a:ext cx="8915400" cy="98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377720"/>
            <a:ext cx="8915400" cy="38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4000"/>
          </a:bodyPr>
          <a:p>
            <a:pPr marL="322200" indent="-3222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698400" indent="-2685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074240" indent="-2145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04080" indent="-2145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933920" indent="-2145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933920" indent="-2145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933920" indent="-2145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5471640"/>
            <a:ext cx="2311200" cy="31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5471640"/>
            <a:ext cx="3136680" cy="31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5471640"/>
            <a:ext cx="2311560" cy="31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334D9B-72D3-43DE-8BE8-99BFF2A051F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0" y="0"/>
            <a:ext cx="9906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Imagen 115" descr=""/>
          <p:cNvPicPr/>
          <p:nvPr/>
        </p:nvPicPr>
        <p:blipFill>
          <a:blip r:embed="rId1"/>
          <a:stretch/>
        </p:blipFill>
        <p:spPr>
          <a:xfrm>
            <a:off x="920880" y="660240"/>
            <a:ext cx="8447040" cy="388800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5"/>
          <p:cNvSpPr/>
          <p:nvPr/>
        </p:nvSpPr>
        <p:spPr>
          <a:xfrm>
            <a:off x="1492920" y="4542120"/>
            <a:ext cx="832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. In vitro model of bacterial colonization of endometrial epithelium mimicking LD vs NLD condi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03T14:32:23Z</dcterms:created>
  <dc:creator>Empar Chenoll</dc:creator>
  <dc:description/>
  <dc:language>en-US</dc:language>
  <cp:lastModifiedBy>EMPAR</cp:lastModifiedBy>
  <dcterms:modified xsi:type="dcterms:W3CDTF">2018-12-24T12:22:37Z</dcterms:modified>
  <cp:revision>2</cp:revision>
  <dc:subject/>
  <dc:title>Diapositiva 1</dc:title>
</cp:coreProperties>
</file>